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151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057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607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649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57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590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86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700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55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083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399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72567D-0A4D-7045-B2AA-8441F5961C5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89C63B-5244-9542-B209-BC657196EB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623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4FA9ACF-BBE1-EE5E-97C8-D56FFBFB9E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4257436"/>
              </p:ext>
            </p:extLst>
          </p:nvPr>
        </p:nvGraphicFramePr>
        <p:xfrm>
          <a:off x="3396013" y="1086318"/>
          <a:ext cx="3343999" cy="24815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81607">
                  <a:extLst>
                    <a:ext uri="{9D8B030D-6E8A-4147-A177-3AD203B41FA5}">
                      <a16:colId xmlns:a16="http://schemas.microsoft.com/office/drawing/2014/main" val="44988367"/>
                    </a:ext>
                  </a:extLst>
                </a:gridCol>
                <a:gridCol w="566550">
                  <a:extLst>
                    <a:ext uri="{9D8B030D-6E8A-4147-A177-3AD203B41FA5}">
                      <a16:colId xmlns:a16="http://schemas.microsoft.com/office/drawing/2014/main" val="3485466160"/>
                    </a:ext>
                  </a:extLst>
                </a:gridCol>
                <a:gridCol w="582303">
                  <a:extLst>
                    <a:ext uri="{9D8B030D-6E8A-4147-A177-3AD203B41FA5}">
                      <a16:colId xmlns:a16="http://schemas.microsoft.com/office/drawing/2014/main" val="2849091112"/>
                    </a:ext>
                  </a:extLst>
                </a:gridCol>
                <a:gridCol w="565006">
                  <a:extLst>
                    <a:ext uri="{9D8B030D-6E8A-4147-A177-3AD203B41FA5}">
                      <a16:colId xmlns:a16="http://schemas.microsoft.com/office/drawing/2014/main" val="194275125"/>
                    </a:ext>
                  </a:extLst>
                </a:gridCol>
                <a:gridCol w="448533">
                  <a:extLst>
                    <a:ext uri="{9D8B030D-6E8A-4147-A177-3AD203B41FA5}">
                      <a16:colId xmlns:a16="http://schemas.microsoft.com/office/drawing/2014/main" val="2325649933"/>
                    </a:ext>
                  </a:extLst>
                </a:gridCol>
              </a:tblGrid>
              <a:tr h="15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KP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6957136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5145390"/>
                  </a:ext>
                </a:extLst>
              </a:tr>
              <a:tr h="15663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≥1/1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9456288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54737919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8901136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KRAS K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46366580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7060725"/>
                  </a:ext>
                </a:extLst>
              </a:tr>
              <a:tr h="178383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≥1/2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45324273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26420165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63485927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DK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69692029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4009744"/>
                  </a:ext>
                </a:extLst>
              </a:tr>
              <a:tr h="11961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≥1/86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0186330"/>
                  </a:ext>
                </a:extLst>
              </a:tr>
              <a:tr h="154507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3061952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32E3C9A-7861-5419-0F04-68E997B09840}"/>
              </a:ext>
            </a:extLst>
          </p:cNvPr>
          <p:cNvSpPr txBox="1"/>
          <p:nvPr/>
        </p:nvSpPr>
        <p:spPr>
          <a:xfrm>
            <a:off x="596566" y="345036"/>
            <a:ext cx="3234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G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umor Initiating Cells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LDA: Extreme Limiting Dilution Analysis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D300D41A-0084-AAB1-FFF1-87012CA19A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4768968"/>
              </p:ext>
            </p:extLst>
          </p:nvPr>
        </p:nvGraphicFramePr>
        <p:xfrm>
          <a:off x="906952" y="2976430"/>
          <a:ext cx="1637413" cy="60076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0815">
                  <a:extLst>
                    <a:ext uri="{9D8B030D-6E8A-4147-A177-3AD203B41FA5}">
                      <a16:colId xmlns:a16="http://schemas.microsoft.com/office/drawing/2014/main" val="3146160636"/>
                    </a:ext>
                  </a:extLst>
                </a:gridCol>
                <a:gridCol w="370815">
                  <a:extLst>
                    <a:ext uri="{9D8B030D-6E8A-4147-A177-3AD203B41FA5}">
                      <a16:colId xmlns:a16="http://schemas.microsoft.com/office/drawing/2014/main" val="1505319667"/>
                    </a:ext>
                  </a:extLst>
                </a:gridCol>
                <a:gridCol w="370815">
                  <a:extLst>
                    <a:ext uri="{9D8B030D-6E8A-4147-A177-3AD203B41FA5}">
                      <a16:colId xmlns:a16="http://schemas.microsoft.com/office/drawing/2014/main" val="4017088061"/>
                    </a:ext>
                  </a:extLst>
                </a:gridCol>
                <a:gridCol w="524968">
                  <a:extLst>
                    <a:ext uri="{9D8B030D-6E8A-4147-A177-3AD203B41FA5}">
                      <a16:colId xmlns:a16="http://schemas.microsoft.com/office/drawing/2014/main" val="2675508163"/>
                    </a:ext>
                  </a:extLst>
                </a:gridCol>
              </a:tblGrid>
              <a:tr h="13855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556070899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316156765"/>
                  </a:ext>
                </a:extLst>
              </a:tr>
              <a:tr h="13022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080902294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690624244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479070582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124189015"/>
                  </a:ext>
                </a:extLst>
              </a:tr>
              <a:tr h="13022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38209397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404916863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039189008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99500342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076871001"/>
                  </a:ext>
                </a:extLst>
              </a:tr>
              <a:tr h="13022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484417698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67064234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551780681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363863231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400304709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733732224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026185807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85809199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985779229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37190257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106314990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21504503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127568552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39118452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193834274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49495031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646750584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75181088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40337547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348733310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677858916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4077918927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387081733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1804202609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412626231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938880155"/>
                  </a:ext>
                </a:extLst>
              </a:tr>
              <a:tr h="12208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95" marR="5695" marT="5695" marB="0" anchor="b"/>
                </a:tc>
                <a:extLst>
                  <a:ext uri="{0D108BD9-81ED-4DB2-BD59-A6C34878D82A}">
                    <a16:rowId xmlns:a16="http://schemas.microsoft.com/office/drawing/2014/main" val="278017576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37D3A32-6F69-9288-D56C-191A5C7EE332}"/>
              </a:ext>
            </a:extLst>
          </p:cNvPr>
          <p:cNvSpPr txBox="1"/>
          <p:nvPr/>
        </p:nvSpPr>
        <p:spPr>
          <a:xfrm>
            <a:off x="2576263" y="3858933"/>
            <a:ext cx="1681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= KPC parental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8EB696-3C08-7637-B679-1E8D7E2490D1}"/>
              </a:ext>
            </a:extLst>
          </p:cNvPr>
          <p:cNvSpPr txBox="1"/>
          <p:nvPr/>
        </p:nvSpPr>
        <p:spPr>
          <a:xfrm>
            <a:off x="2601071" y="5797602"/>
            <a:ext cx="1999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= KRAS KO derived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544573-7F91-F558-0D18-5D21CB59357F}"/>
              </a:ext>
            </a:extLst>
          </p:cNvPr>
          <p:cNvSpPr txBox="1"/>
          <p:nvPr/>
        </p:nvSpPr>
        <p:spPr>
          <a:xfrm>
            <a:off x="2594490" y="7555519"/>
            <a:ext cx="261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= KRAS/STAT3 DKO derived cel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AD9208-C3ED-D101-998E-A4FC07D48BC8}"/>
              </a:ext>
            </a:extLst>
          </p:cNvPr>
          <p:cNvSpPr txBox="1"/>
          <p:nvPr/>
        </p:nvSpPr>
        <p:spPr>
          <a:xfrm rot="16200000">
            <a:off x="-127951" y="3749063"/>
            <a:ext cx="1582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# cells implanted S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7DD350-E79F-10CB-75EB-1253A85E7812}"/>
              </a:ext>
            </a:extLst>
          </p:cNvPr>
          <p:cNvSpPr txBox="1"/>
          <p:nvPr/>
        </p:nvSpPr>
        <p:spPr>
          <a:xfrm rot="16200000">
            <a:off x="-103142" y="5762161"/>
            <a:ext cx="1582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# cells implanted 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8F9944-7EF7-C1A7-CB9F-E3987FC788AF}"/>
              </a:ext>
            </a:extLst>
          </p:cNvPr>
          <p:cNvSpPr txBox="1"/>
          <p:nvPr/>
        </p:nvSpPr>
        <p:spPr>
          <a:xfrm rot="16200000">
            <a:off x="-92510" y="7878041"/>
            <a:ext cx="1582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# cells implanted S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B2F735A-4144-0A9E-2BF5-C23946FB484D}"/>
              </a:ext>
            </a:extLst>
          </p:cNvPr>
          <p:cNvSpPr txBox="1"/>
          <p:nvPr/>
        </p:nvSpPr>
        <p:spPr>
          <a:xfrm>
            <a:off x="1534044" y="2639733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</a:p>
        </p:txBody>
      </p:sp>
    </p:spTree>
    <p:extLst>
      <p:ext uri="{BB962C8B-B14F-4D97-AF65-F5344CB8AC3E}">
        <p14:creationId xmlns:p14="http://schemas.microsoft.com/office/powerpoint/2010/main" val="2216803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30</Words>
  <Application>Microsoft Macintosh PowerPoint</Application>
  <PresentationFormat>On-screen Show (4:3)</PresentationFormat>
  <Paragraphs>1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2</cp:revision>
  <dcterms:created xsi:type="dcterms:W3CDTF">2025-06-10T17:38:06Z</dcterms:created>
  <dcterms:modified xsi:type="dcterms:W3CDTF">2025-06-10T17:39:55Z</dcterms:modified>
</cp:coreProperties>
</file>